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FBFB"/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14" y="90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68CFA-9254-40F4-AC3B-B1CAB47EB0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87451D-96A9-4E65-9BC2-208A78DA84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73A3A0-8F45-4E53-966E-C4138BC5F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DA82A-79A9-4118-8EC0-34F93D037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5D9AE-A2AD-4F24-917A-C5F2F2287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421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9EE7B-5DDC-4F84-AB90-101CEBC1B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3A9B6A-EBEC-4EA7-98B1-9405008056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979310-77BB-4B99-92C6-AD4393CB1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414AD-F4CA-478B-B491-349F5DDA7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EAE1A5-5341-486D-9AAC-2F5E15945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590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59A103-76C3-4329-B175-5812013393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3E6A02-CF90-4859-857B-903DFEE1C3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94B4E-D42A-478C-81F7-E67461005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33BD81-C841-4629-931C-71893B37D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E663A-EF88-4BA2-B021-6F279BC10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448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D3C8B7-3349-4D9B-B7DF-454265FB3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B8F34A-0A84-4CD2-B2EA-E045E1F102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0D2BF1-FC76-49FF-B1A0-D5FBB8305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873558-36DB-4732-8183-0B951C10B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970EB-0A60-4F08-9F54-A21E48A67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323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C87229-97AD-4D71-97F8-692D97765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AD3334-1A0D-4856-8E42-A015B16F8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847690-3500-40BB-A9BE-29960BD5A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359689-7C6D-4D41-8CDC-BBBDA13B1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9AD22A-0D60-4039-8F91-2CB0C167E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654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5CA3E-5E5E-41AF-9346-CE12A4432A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D244EC-6C0D-472E-9448-B007BE0FAD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402900-D680-4525-92F8-8439226FF6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D0346F-1FF6-47FA-80FF-EF8EF2136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F4C58D-3F65-4F9D-8085-E180DC14A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D2CD3F-5D58-4A67-9303-09D54E187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788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D8D50-572E-4174-B53A-A576E460C4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27E11C-32AF-49E8-AD72-3E8124D21E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8E9761-3313-42C5-B023-A8C24AE597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DB015C0-2E9E-4A78-BF55-2BE3F4FFF7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F10CA4-8F98-4B9B-8F29-4D52723E26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285AF0-0F3B-409B-B659-BE12FBD7A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B02D54-FFF1-4344-9661-5B1ED41C5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43400A-7D05-4961-B984-84A259B180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933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5EB64-5B9C-4BC4-A468-ACD858675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7594D5-ED69-4D80-8206-6192CB0DD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E480A8-7B67-499A-9241-D74571446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BC22ED-4D1F-4421-84AD-8DA3880B1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818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BA91B2-F509-4E7F-8798-AA3B2D94F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9DCEEA-E576-463E-AFE3-2CF5E382C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8CCFAE-1D7D-4F5E-8198-FB2497823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449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E7258-76ED-4C18-840D-9029B5E8E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FF5DD5-C880-4543-8F6E-36FD113392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600813-EA94-4273-8A54-C8404D137F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CF1C40-E16C-4B82-B5DC-3875A4C3F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667FA4-BFC0-4E7C-B180-1C4553057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717497-8E5B-44B5-8CCD-CCB85FA06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705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5BEC7B-CAEB-4E4B-BB62-449414D45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D45D6C-A419-4ABD-86B7-705691FA18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6E0405-D939-491C-9119-F11FBE4B0F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68D55D-3D6E-4AE7-985F-646040604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E88FF2-6FDE-4EF0-960C-328A68B54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D8A37B-895A-42D2-9C5E-B550B9978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9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0BF2C4-C87C-4DD8-B72F-5639F6D5A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9BDA72-FA0C-406B-8AA2-BF2865BB25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C9D75C-F0B7-49C5-BF47-2754650427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8C60B1-CE71-45C8-9EC8-4B5F68F3B1D4}" type="datetimeFigureOut">
              <a:rPr lang="en-US" smtClean="0"/>
              <a:t>9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ED2DE-83E6-4A68-ADEB-9DBABC7293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4D9749-1E5F-4560-A459-2B48B273C4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D0441-44D3-4696-9D08-78C5EB910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899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E26BB36-EAE8-4F40-B6EB-AE1B7DAE4AEA}"/>
              </a:ext>
            </a:extLst>
          </p:cNvPr>
          <p:cNvSpPr txBox="1"/>
          <p:nvPr/>
        </p:nvSpPr>
        <p:spPr>
          <a:xfrm>
            <a:off x="-95250" y="290886"/>
            <a:ext cx="12382500" cy="12704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/>
              <a:t>Fructose Intake and its Association with Relative Telomere Length: </a:t>
            </a:r>
            <a:r>
              <a:rPr lang="en-US" sz="2400" b="1" dirty="0" smtClean="0"/>
              <a:t>An Exploratory Study </a:t>
            </a:r>
            <a:r>
              <a:rPr lang="en-US" sz="2400" b="1" dirty="0"/>
              <a:t>among Healthy Lebanese Adults</a:t>
            </a:r>
            <a:endParaRPr lang="en-US" sz="2400" dirty="0"/>
          </a:p>
          <a:p>
            <a:pPr marL="0" marR="0" indent="0" algn="ctr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2400" kern="1400" dirty="0">
                <a:ln>
                  <a:noFill/>
                </a:ln>
                <a:solidFill>
                  <a:srgbClr val="000000"/>
                </a:solidFill>
                <a:effectLst/>
              </a:rPr>
              <a:t> </a:t>
            </a:r>
          </a:p>
        </p:txBody>
      </p:sp>
      <p:pic>
        <p:nvPicPr>
          <p:cNvPr id="1026" name="Picture 2" descr="DNA methylation closely linked to telomere length"/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8152" y="4627899"/>
            <a:ext cx="1523076" cy="8587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04800" y="1257300"/>
            <a:ext cx="11620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Objective: (1) Assessing </a:t>
            </a:r>
            <a:r>
              <a:rPr lang="en-GB" dirty="0"/>
              <a:t>the intake of dietary fructose (total, added and natural) in a sample of Lebanese adults and (2) </a:t>
            </a:r>
            <a:r>
              <a:rPr lang="en-GB" dirty="0" smtClean="0"/>
              <a:t>investigate </a:t>
            </a:r>
            <a:r>
              <a:rPr lang="en-GB" dirty="0"/>
              <a:t>dietary fructose as a predictor of short telomere </a:t>
            </a:r>
            <a:r>
              <a:rPr lang="en-GB" dirty="0" smtClean="0"/>
              <a:t>length.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83207" y="2042593"/>
            <a:ext cx="1990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ethods</a:t>
            </a:r>
            <a:endParaRPr lang="en-US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A8B464C-E75E-4E47-A7D5-E40D9E13396E}"/>
              </a:ext>
            </a:extLst>
          </p:cNvPr>
          <p:cNvSpPr txBox="1"/>
          <p:nvPr/>
        </p:nvSpPr>
        <p:spPr>
          <a:xfrm>
            <a:off x="276224" y="2464094"/>
            <a:ext cx="40386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Cross-sectional </a:t>
            </a:r>
            <a:r>
              <a:rPr kumimoji="0" lang="en-US" altLang="zh-CN" sz="18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SimSun" panose="02010600030101010101" pitchFamily="2" charset="-122"/>
                <a:cs typeface="Times New Roman" panose="02020603050405020304" pitchFamily="18" charset="0"/>
              </a:rPr>
              <a:t>survey </a:t>
            </a:r>
            <a:endParaRPr lang="en-US" i="1" dirty="0"/>
          </a:p>
        </p:txBody>
      </p:sp>
      <p:sp>
        <p:nvSpPr>
          <p:cNvPr id="7" name="TextBox 6"/>
          <p:cNvSpPr txBox="1"/>
          <p:nvPr/>
        </p:nvSpPr>
        <p:spPr>
          <a:xfrm>
            <a:off x="304800" y="2974495"/>
            <a:ext cx="252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282 Lebanese adult </a:t>
            </a:r>
            <a:endParaRPr lang="en-US" i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63" t="20553" r="19763" b="20949"/>
          <a:stretch/>
        </p:blipFill>
        <p:spPr>
          <a:xfrm>
            <a:off x="2295524" y="2917933"/>
            <a:ext cx="426695" cy="42858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72" t="1" r="18204" b="31852"/>
          <a:stretch/>
        </p:blipFill>
        <p:spPr>
          <a:xfrm flipH="1">
            <a:off x="2832100" y="2776758"/>
            <a:ext cx="560875" cy="61982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04800" y="3656406"/>
            <a:ext cx="292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Data collection:</a:t>
            </a:r>
            <a:endParaRPr lang="en-US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304800" y="4211748"/>
            <a:ext cx="3225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) Questionnaires (socio-demographics, </a:t>
            </a:r>
            <a:r>
              <a:rPr lang="en-US" sz="1400" dirty="0" smtClean="0"/>
              <a:t>lifestyle, </a:t>
            </a:r>
            <a:r>
              <a:rPr lang="en-US" sz="1400" dirty="0" smtClean="0"/>
              <a:t>sleep habits)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304800" y="4915986"/>
            <a:ext cx="17240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) </a:t>
            </a:r>
            <a:r>
              <a:rPr lang="en-US" sz="1400" dirty="0" smtClean="0"/>
              <a:t>Food Frequency Questionnaire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04800" y="5557948"/>
            <a:ext cx="218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) Anthropometrics 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2114547" y="6192948"/>
            <a:ext cx="239174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4) </a:t>
            </a:r>
            <a:r>
              <a:rPr lang="en-US" sz="1400" dirty="0" smtClean="0"/>
              <a:t>Relative Telomere Length (RTL) and biochemical assessment</a:t>
            </a:r>
            <a:endParaRPr lang="en-US" sz="14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267" y="5335158"/>
            <a:ext cx="376664" cy="70509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4" t="19260" r="20000" b="20926"/>
          <a:stretch/>
        </p:blipFill>
        <p:spPr>
          <a:xfrm>
            <a:off x="2501900" y="5326885"/>
            <a:ext cx="716929" cy="70385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8" t="12132" r="22740" b="14792"/>
          <a:stretch/>
        </p:blipFill>
        <p:spPr>
          <a:xfrm>
            <a:off x="3206748" y="5323722"/>
            <a:ext cx="546100" cy="6985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6" t="6111" r="6667" b="6296"/>
          <a:stretch/>
        </p:blipFill>
        <p:spPr>
          <a:xfrm>
            <a:off x="2400974" y="4452931"/>
            <a:ext cx="711563" cy="710062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35"/>
          <a:stretch/>
        </p:blipFill>
        <p:spPr>
          <a:xfrm>
            <a:off x="587555" y="6060964"/>
            <a:ext cx="600699" cy="67451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7" t="235" r="5405"/>
          <a:stretch/>
        </p:blipFill>
        <p:spPr>
          <a:xfrm>
            <a:off x="1240494" y="6011712"/>
            <a:ext cx="589889" cy="740803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6424613" y="2042593"/>
            <a:ext cx="1990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Results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302248" y="2414336"/>
            <a:ext cx="5530852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i="1" dirty="0" smtClean="0"/>
              <a:t>Average total fructose intake: </a:t>
            </a:r>
            <a:r>
              <a:rPr lang="en-US" dirty="0" smtClean="0"/>
              <a:t>51.31 g/day i.e. 6.58% EI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5302248" y="2881578"/>
            <a:ext cx="5530852" cy="36933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i="1" dirty="0" smtClean="0"/>
              <a:t>Average natural fructose intake: </a:t>
            </a:r>
            <a:r>
              <a:rPr lang="en-US" dirty="0" smtClean="0"/>
              <a:t>12.28 g/day i.e. 1.78% EI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5311774" y="3347730"/>
            <a:ext cx="5530852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Average added fructose intake: 39.03 g/day i.e. 4.8% EI</a:t>
            </a:r>
            <a:endParaRPr lang="en-US" dirty="0"/>
          </a:p>
        </p:txBody>
      </p:sp>
      <p:sp>
        <p:nvSpPr>
          <p:cNvPr id="24" name="Up Arrow 23"/>
          <p:cNvSpPr/>
          <p:nvPr/>
        </p:nvSpPr>
        <p:spPr>
          <a:xfrm>
            <a:off x="5600700" y="4597400"/>
            <a:ext cx="495300" cy="726322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6273800" y="4734968"/>
            <a:ext cx="180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otal and added fructose intakes </a:t>
            </a:r>
            <a:endParaRPr lang="en-US" dirty="0"/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8077200" y="5042986"/>
            <a:ext cx="11049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Down Arrow 29"/>
          <p:cNvSpPr/>
          <p:nvPr/>
        </p:nvSpPr>
        <p:spPr>
          <a:xfrm>
            <a:off x="9296400" y="4597400"/>
            <a:ext cx="493776" cy="72237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10083800" y="4858320"/>
            <a:ext cx="514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RTL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6424613" y="5486809"/>
            <a:ext cx="1990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onclusion</a:t>
            </a:r>
            <a:endParaRPr lang="en-US" b="1" dirty="0"/>
          </a:p>
        </p:txBody>
      </p:sp>
      <p:sp>
        <p:nvSpPr>
          <p:cNvPr id="31" name="Rounded Rectangle 30"/>
          <p:cNvSpPr/>
          <p:nvPr/>
        </p:nvSpPr>
        <p:spPr>
          <a:xfrm>
            <a:off x="5049837" y="5902758"/>
            <a:ext cx="6197600" cy="81774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dirty="0">
                <a:solidFill>
                  <a:schemeClr val="tx1"/>
                </a:solidFill>
              </a:rPr>
              <a:t>Larger studies, of longitudinal nature, are needed to confirm and better elucidate the relationship between fructose intakes and telomere length.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311774" y="3841072"/>
            <a:ext cx="5530852" cy="6463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Mean WC and mean LDL-C were significantly higher in participants with shorter RT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1586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</TotalTime>
  <Words>176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ra Chehade</dc:creator>
  <cp:lastModifiedBy>Lara Nasreddine</cp:lastModifiedBy>
  <cp:revision>15</cp:revision>
  <dcterms:created xsi:type="dcterms:W3CDTF">2022-12-20T12:02:39Z</dcterms:created>
  <dcterms:modified xsi:type="dcterms:W3CDTF">2023-09-14T14:44:34Z</dcterms:modified>
</cp:coreProperties>
</file>